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77FA768-DE87-0AE1-E1DF-D8A4F1D8EEAE}" name="ANNA MARIA VAIRA" initials="AV" userId="S::annamaria.vaira@cnr.it::07571697-e96e-4085-b98c-c13b660e500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>
        <p:scale>
          <a:sx n="250" d="100"/>
          <a:sy n="250" d="100"/>
        </p:scale>
        <p:origin x="180" y="-7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mmond, John - REE-ARS" userId="c4636370-9abd-41f3-81dc-0529d80fa84a" providerId="ADAL" clId="{18A31F76-4BC4-42CE-BE7B-1592033218EE}"/>
    <pc:docChg chg="modSld">
      <pc:chgData name="Hammond, John - REE-ARS" userId="c4636370-9abd-41f3-81dc-0529d80fa84a" providerId="ADAL" clId="{18A31F76-4BC4-42CE-BE7B-1592033218EE}" dt="2025-03-09T19:18:50.415" v="1" actId="13926"/>
      <pc:docMkLst>
        <pc:docMk/>
      </pc:docMkLst>
      <pc:sldChg chg="modSp mod">
        <pc:chgData name="Hammond, John - REE-ARS" userId="c4636370-9abd-41f3-81dc-0529d80fa84a" providerId="ADAL" clId="{18A31F76-4BC4-42CE-BE7B-1592033218EE}" dt="2025-03-09T19:18:50.415" v="1" actId="13926"/>
        <pc:sldMkLst>
          <pc:docMk/>
          <pc:sldMk cId="3789454844" sldId="256"/>
        </pc:sldMkLst>
        <pc:spChg chg="mod">
          <ac:chgData name="Hammond, John - REE-ARS" userId="c4636370-9abd-41f3-81dc-0529d80fa84a" providerId="ADAL" clId="{18A31F76-4BC4-42CE-BE7B-1592033218EE}" dt="2025-03-09T19:18:50.415" v="1" actId="13926"/>
          <ac:spMkLst>
            <pc:docMk/>
            <pc:sldMk cId="3789454844" sldId="256"/>
            <ac:spMk id="4" creationId="{976A31BA-9A14-72ED-1621-20005B7CA34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9613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4374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79532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46769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4005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8271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38119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4164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125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7476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0871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B4238F-8988-4C26-8A3B-D1F8E61227D0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01003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4EED26EE-DA20-DB8E-1692-8332112001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069" y="1135463"/>
            <a:ext cx="6137861" cy="5275386"/>
          </a:xfrm>
          <a:prstGeom prst="rect">
            <a:avLst/>
          </a:prstGeom>
        </p:spPr>
      </p:pic>
      <p:sp>
        <p:nvSpPr>
          <p:cNvPr id="4" name="CasellaDiTesto 15">
            <a:extLst>
              <a:ext uri="{FF2B5EF4-FFF2-40B4-BE49-F238E27FC236}">
                <a16:creationId xmlns:a16="http://schemas.microsoft.com/office/drawing/2014/main" id="{976A31BA-9A14-72ED-1621-20005B7CA34B}"/>
              </a:ext>
            </a:extLst>
          </p:cNvPr>
          <p:cNvSpPr txBox="1"/>
          <p:nvPr/>
        </p:nvSpPr>
        <p:spPr>
          <a:xfrm>
            <a:off x="259430" y="7151654"/>
            <a:ext cx="6162675" cy="8309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Figure S2.</a:t>
            </a:r>
            <a:r>
              <a:rPr lang="en-US" sz="1200" dirty="0">
                <a:latin typeface="Times New Roman"/>
                <a:cs typeface="Times New Roman"/>
              </a:rPr>
              <a:t> Similarity matrix of RNA-dependent RNA polymerase aminoacidic sequences of selected viral species listed in the </a:t>
            </a:r>
            <a:r>
              <a:rPr lang="en-US" sz="1200" i="1" dirty="0" err="1">
                <a:latin typeface="Times New Roman"/>
                <a:cs typeface="Times New Roman"/>
              </a:rPr>
              <a:t>Hareavirales</a:t>
            </a:r>
            <a:r>
              <a:rPr lang="en-US" sz="1200" dirty="0">
                <a:latin typeface="Times New Roman"/>
                <a:cs typeface="Times New Roman"/>
              </a:rPr>
              <a:t> order, the official species and the newly discovered species possibly listing in the </a:t>
            </a:r>
            <a:r>
              <a:rPr lang="en-US" sz="1200" i="1" dirty="0">
                <a:latin typeface="Times New Roman"/>
                <a:cs typeface="Times New Roman"/>
              </a:rPr>
              <a:t>Konkoviridae</a:t>
            </a:r>
            <a:r>
              <a:rPr lang="en-US" sz="1200" dirty="0">
                <a:latin typeface="Times New Roman"/>
                <a:cs typeface="Times New Roman"/>
              </a:rPr>
              <a:t> family (for which the RNA-2 full CDS has been obtained), obtained by Sequence Demarcation Tool (SDT) v.1.2</a:t>
            </a:r>
            <a:endParaRPr lang="it-IT" sz="1200" dirty="0">
              <a:solidFill>
                <a:srgbClr val="FF0000"/>
              </a:solidFill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789454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dc1a3a29-1734-4967-8cff-d351e6fc4f0c" xsi:nil="true"/>
    <lcf76f155ced4ddcb4097134ff3c332f xmlns="78083c92-0af9-4662-99b5-5fe34061947b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D3896766B253BF4C954DE14C4319FB08" ma:contentTypeVersion="11" ma:contentTypeDescription="Creare un nuovo documento." ma:contentTypeScope="" ma:versionID="55f3245f08a521eb9542d035c68db22e">
  <xsd:schema xmlns:xsd="http://www.w3.org/2001/XMLSchema" xmlns:xs="http://www.w3.org/2001/XMLSchema" xmlns:p="http://schemas.microsoft.com/office/2006/metadata/properties" xmlns:ns2="78083c92-0af9-4662-99b5-5fe34061947b" xmlns:ns3="dc1a3a29-1734-4967-8cff-d351e6fc4f0c" targetNamespace="http://schemas.microsoft.com/office/2006/metadata/properties" ma:root="true" ma:fieldsID="b9c0ba933e2b573af2568ceb043f1f1b" ns2:_="" ns3:_="">
    <xsd:import namespace="78083c92-0af9-4662-99b5-5fe34061947b"/>
    <xsd:import namespace="dc1a3a29-1734-4967-8cff-d351e6fc4f0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83c92-0af9-4662-99b5-5fe34061947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3" nillable="true" ma:taxonomy="true" ma:internalName="lcf76f155ced4ddcb4097134ff3c332f" ma:taxonomyFieldName="MediaServiceImageTags" ma:displayName="Tag immagine" ma:readOnly="false" ma:fieldId="{5cf76f15-5ced-4ddc-b409-7134ff3c332f}" ma:taxonomyMulti="true" ma:sspId="e5505f8f-da62-40e5-a116-f08e7003152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c1a3a29-1734-4967-8cff-d351e6fc4f0c" elementFormDefault="qualified">
    <xsd:import namespace="http://schemas.microsoft.com/office/2006/documentManagement/types"/>
    <xsd:import namespace="http://schemas.microsoft.com/office/infopath/2007/PartnerControls"/>
    <xsd:element name="TaxCatchAll" ma:index="14" nillable="true" ma:displayName="Taxonomy Catch All Column" ma:hidden="true" ma:list="{e8a6735f-476e-414a-bdf7-a56c8e7d8966}" ma:internalName="TaxCatchAll" ma:showField="CatchAllData" ma:web="dc1a3a29-1734-4967-8cff-d351e6fc4f0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21B57CB-2989-49F3-9B3C-01B7E85A2D3A}">
  <ds:schemaRefs>
    <ds:schemaRef ds:uri="dc1a3a29-1734-4967-8cff-d351e6fc4f0c"/>
    <ds:schemaRef ds:uri="http://schemas.microsoft.com/office/2006/metadata/properties"/>
    <ds:schemaRef ds:uri="http://purl.org/dc/terms/"/>
    <ds:schemaRef ds:uri="http://schemas.microsoft.com/office/2006/documentManagement/types"/>
    <ds:schemaRef ds:uri="http://www.w3.org/XML/1998/namespace"/>
    <ds:schemaRef ds:uri="78083c92-0af9-4662-99b5-5fe34061947b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B0C146D0-C203-4C7D-9184-64CE2F65C57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A9C1446-F9F7-4BCA-A6B4-823C288CEA9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83c92-0af9-4662-99b5-5fe34061947b"/>
    <ds:schemaRef ds:uri="dc1a3a29-1734-4967-8cff-d351e6fc4f0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4</TotalTime>
  <Words>57</Words>
  <Application>Microsoft Office PowerPoint</Application>
  <PresentationFormat>A4 (21x29,7 cm)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URA MIOZZI</dc:creator>
  <cp:lastModifiedBy>LAURA MIOZZI</cp:lastModifiedBy>
  <cp:revision>29</cp:revision>
  <dcterms:created xsi:type="dcterms:W3CDTF">2024-12-17T14:13:40Z</dcterms:created>
  <dcterms:modified xsi:type="dcterms:W3CDTF">2025-03-17T08:57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3896766B253BF4C954DE14C4319FB08</vt:lpwstr>
  </property>
  <property fmtid="{D5CDD505-2E9C-101B-9397-08002B2CF9AE}" pid="3" name="MediaServiceImageTags">
    <vt:lpwstr/>
  </property>
</Properties>
</file>